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582" t="2814" r="27069" b="3618"/>
          <a:stretch/>
        </p:blipFill>
        <p:spPr>
          <a:xfrm>
            <a:off x="300311" y="715990"/>
            <a:ext cx="1935128" cy="154703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2878" t="2211" r="27546" b="3257"/>
          <a:stretch/>
        </p:blipFill>
        <p:spPr>
          <a:xfrm>
            <a:off x="2316792" y="700051"/>
            <a:ext cx="1913864" cy="156297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/>
          <a:srcRect l="2741" t="2614" r="27683" b="3174"/>
          <a:stretch/>
        </p:blipFill>
        <p:spPr>
          <a:xfrm>
            <a:off x="4309596" y="682869"/>
            <a:ext cx="1913864" cy="155768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74541" t="43508" r="2392" b="43507"/>
          <a:stretch/>
        </p:blipFill>
        <p:spPr>
          <a:xfrm>
            <a:off x="382098" y="791475"/>
            <a:ext cx="634516" cy="21469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149455" y="281192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562 GRO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00206" y="48621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78365" y="486251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95594" y="486212"/>
            <a:ext cx="739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02719" y="7557686"/>
            <a:ext cx="16417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ance to centers 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/>
          <a:srcRect l="2773" t="2447" r="26985" b="2694"/>
          <a:stretch/>
        </p:blipFill>
        <p:spPr>
          <a:xfrm>
            <a:off x="231023" y="3082583"/>
            <a:ext cx="1932184" cy="1568378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7"/>
          <a:srcRect l="2990" t="2085" r="27419" b="3416"/>
          <a:stretch/>
        </p:blipFill>
        <p:spPr>
          <a:xfrm>
            <a:off x="2298496" y="3088535"/>
            <a:ext cx="1914277" cy="156242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/>
          <a:srcRect l="2557" t="2007" r="27636" b="3134"/>
          <a:stretch/>
        </p:blipFill>
        <p:spPr>
          <a:xfrm>
            <a:off x="4340113" y="3082583"/>
            <a:ext cx="1920218" cy="156837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149455" y="2605517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562 PRO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8"/>
          <a:srcRect l="2719" t="2847" r="27473" b="2996"/>
          <a:stretch/>
        </p:blipFill>
        <p:spPr>
          <a:xfrm>
            <a:off x="445726" y="5445410"/>
            <a:ext cx="2560320" cy="2075688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9"/>
          <a:srcRect l="2111" t="1757" r="27084" b="2842"/>
          <a:stretch/>
        </p:blipFill>
        <p:spPr>
          <a:xfrm>
            <a:off x="3415648" y="5406705"/>
            <a:ext cx="2596897" cy="210312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290545" y="4692202"/>
            <a:ext cx="16417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ance to centers 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298438" y="2307159"/>
            <a:ext cx="16417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ance to centers 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777040" y="4963268"/>
            <a:ext cx="16470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use liver PRO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22019" y="281511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63787" y="2813576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936674" y="2815151"/>
            <a:ext cx="739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348135" y="520171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36111" y="5199230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514340" y="3677909"/>
            <a:ext cx="14494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Fragment per </a:t>
            </a:r>
            <a:r>
              <a:rPr lang="en-US" sz="800" b="1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 per peak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493695" y="1332986"/>
            <a:ext cx="14494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Fragment per </a:t>
            </a:r>
            <a:r>
              <a:rPr lang="en-US" sz="800" b="1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 per peak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-260822" y="6235702"/>
            <a:ext cx="14494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Fragment per </a:t>
            </a:r>
            <a:r>
              <a:rPr lang="en-US" sz="800" b="1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 per peak</a:t>
            </a: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/>
          <a:srcRect l="74541" t="43508" r="2392" b="43507"/>
          <a:stretch/>
        </p:blipFill>
        <p:spPr>
          <a:xfrm>
            <a:off x="382098" y="3143543"/>
            <a:ext cx="634516" cy="214691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5"/>
          <a:srcRect l="74541" t="43508" r="2392" b="43507"/>
          <a:stretch/>
        </p:blipFill>
        <p:spPr>
          <a:xfrm>
            <a:off x="623933" y="5563049"/>
            <a:ext cx="846022" cy="286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4342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48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8</cp:revision>
  <cp:lastPrinted>2016-09-27T21:35:30Z</cp:lastPrinted>
  <dcterms:created xsi:type="dcterms:W3CDTF">2016-09-06T21:27:57Z</dcterms:created>
  <dcterms:modified xsi:type="dcterms:W3CDTF">2018-07-10T18:24:49Z</dcterms:modified>
</cp:coreProperties>
</file>